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9"/>
  </p:notesMasterIdLst>
  <p:sldIdLst>
    <p:sldId id="1228" r:id="rId5"/>
    <p:sldId id="1230" r:id="rId6"/>
    <p:sldId id="1231" r:id="rId7"/>
    <p:sldId id="123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08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20E1B-3E64-4E44-8E49-771258E87053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D803F5-E5D3-4D41-8AC7-7FC948925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99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9EE49-38D6-4E55-82F7-0167DA0C4F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19DFFE-AD1F-40C0-AE24-AD5E52DA0F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94976-3F0B-4E8B-8208-0E05F5583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6FF56-B30B-4E03-A0E4-3A44DDFDF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A31D69-ADC9-448D-999F-3322C0255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361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3560A6-1B23-4BAD-85C3-20AF840C9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558710-DB8E-4B76-900E-595AB1C895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077492-9C61-4150-A5E4-A1ACC8BDD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20ADCE-6EC7-4A66-A5CE-1574F8B09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B5F701-6737-4975-9050-EF10DFE68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809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DC2CCA-2153-406F-B620-5165AEBCC6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EA2FEB-2DD2-4DF4-B55A-69851717A4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964BF9-AAC9-44A1-B686-917DCEDF6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F5B741-C2B1-4C38-ABCA-0707FD7AE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7CB9F-D05B-47D7-8862-CD2E787C4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62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FED64-2978-4906-971A-0C30B02464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3486F9-899E-4E61-BD97-00ECEA97BE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52D7A3-0FB1-4765-804A-66A8CD25C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7A84A8-C772-4AA9-AD01-E4AB5E275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134F50-803E-4A34-9CE4-DFCAF4917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77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27402-B6F7-496F-9168-737333FB0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218033-8254-4069-A7C3-367390B1A7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108C8F-4BE8-412C-A5C5-EBF074346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21C04F-E6BA-469A-B8A0-A7F7F6641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3E45A-275D-4789-9B8A-0F165DE52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712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BD979-90E3-4D18-BF7F-584E3FE4F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0B7C3F-E181-4C40-8551-57491701F9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C314BF-C22E-46FE-99B4-16FF3FD9B6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87D311-995D-4A96-AB63-E246BBCCC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968B2F-F9D9-4A88-9113-0113B4A6C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834612-BC87-4D48-8EF7-F0E896E1A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76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8746D-DB48-45D1-9E4A-BFF87B490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0E256F-32F3-4CD7-8D03-BCB2B75A09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2CBC4C-EAF8-4999-8F86-357FE86F46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C4B1A6-8ECE-4BA8-9F3D-207BF2A055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3FEF7C-628D-4BFC-A986-E51785C46D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E1C663-F600-4659-8A62-31B9D22A9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1394FD-434B-49A0-B7B7-E5AA6D654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F5F51C-A0EF-4A23-91F9-55D0687D5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844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B70E8-54D0-46F9-B69A-CDAFD1DF9D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BE95E5-0977-4EFC-B4E9-74BF587A3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D426E2-1E29-4EEB-B2C2-122B01054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9FAE89-106F-45F7-8FF8-437163202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20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0ECE79-EC41-4291-93C3-122193AE1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1EA767-D8CC-4F85-A306-4379B4E55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FA106E-C4B7-45FC-B960-8FCD9053D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308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D90AD-5063-4E1A-9CD1-9C4D1529D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E132BB-7071-45B8-9D4A-8F5AD9A285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9F5E45-BB35-4CFA-A6C8-3879F4B44E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F475A2-95D4-45B0-8357-3AB34898E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DB3094-A30E-4D54-BCCD-1D870ABC1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854AE6-B70E-4D9B-9AF0-1D674B6CF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546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72D05-1D5F-4C20-A961-91D041AB3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4208714-59FB-404D-855E-91D7E44392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0433D4-7F52-498A-954C-405ACAB40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AE6348-C8B5-4AE2-9EB8-6B87D5442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DE4293-4006-4FC5-87A0-630177536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E6827B-260C-48EA-9024-BD0F7D727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103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8C8844-0AC5-4BD7-82C8-8EACC6453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8825C4-D291-41F3-88AD-8D43FE4FF2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3E45E1-238E-4E7E-8866-BF6B70B73D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8B1C0D-B282-4F21-A9FE-AFBFCF95EA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9A37CF-3812-472A-B598-2DB8F67CC6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980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6A89889-7BF7-444A-9663-47011429483E}"/>
              </a:ext>
            </a:extLst>
          </p:cNvPr>
          <p:cNvSpPr txBox="1"/>
          <p:nvPr/>
        </p:nvSpPr>
        <p:spPr>
          <a:xfrm>
            <a:off x="344904" y="1548063"/>
            <a:ext cx="11662611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le: Distribution of log</a:t>
            </a:r>
            <a:r>
              <a:rPr lang="en-US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for H1-true and H2-true tests of two, three, and four person mixtures by software and mixture ratio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plots shown are distributions of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s) as function of NOC, software, propositions, and mixture ratios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obtained in STRmix (shown in magenta) and EFM (shown in blue) when two, three, and four person mixtures were compared to known contributors (H1-true or sensitivity test).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obtained in STRmix (shown in cyan) and EFM (shown in green) when two, three, and four person mixtures were compared to known non-donors (H2-true or specificity test). The central horizontal line at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= 0 represents neutrality. LR results of 0 are plotted at −125 on the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scale. 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Two H1-true test interpretations of 2P mixtures for which STRmix assigned profile LRs of 0 (plotted in magenta at ratio mixture of 1:4 in the NOC = 2 Person distribution plot) at −125 on the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scale and discussed in detail in Section 3.6. </a:t>
            </a:r>
          </a:p>
          <a:p>
            <a:pPr algn="just"/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46747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7B75F16-F4D3-4561-A06B-9105FF103878}"/>
              </a:ext>
            </a:extLst>
          </p:cNvPr>
          <p:cNvSpPr txBox="1"/>
          <p:nvPr/>
        </p:nvSpPr>
        <p:spPr>
          <a:xfrm>
            <a:off x="-41007" y="-67065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Mixture Ratios for 2 Person Mixture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6E7242C-1EFC-482D-806C-C88B7913C5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9838" y="333045"/>
            <a:ext cx="639651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13607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0F71B40-BDED-47EF-9592-0E375676423C}"/>
              </a:ext>
            </a:extLst>
          </p:cNvPr>
          <p:cNvSpPr txBox="1"/>
          <p:nvPr/>
        </p:nvSpPr>
        <p:spPr>
          <a:xfrm>
            <a:off x="0" y="-72190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Mixture Ratios for 3 Person Mixtur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7F1E6C5-D7BC-4E08-AF8A-580A32CF0D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7005" y="392935"/>
            <a:ext cx="640419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41951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D3A5C35-68BD-42BC-AD1E-95BD3BD20DFD}"/>
              </a:ext>
            </a:extLst>
          </p:cNvPr>
          <p:cNvSpPr txBox="1"/>
          <p:nvPr/>
        </p:nvSpPr>
        <p:spPr>
          <a:xfrm>
            <a:off x="-41007" y="-67065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Mixture Ratios for 4 Person Mixtur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464385A-CB3B-44AC-B2F6-F2AD43F376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5998" y="333045"/>
            <a:ext cx="640419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065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B73957F21AE394984F7C14244486252" ma:contentTypeVersion="2" ma:contentTypeDescription="Create a new document." ma:contentTypeScope="" ma:versionID="9257d4b4774658276c24bca62ab9b61a">
  <xsd:schema xmlns:xsd="http://www.w3.org/2001/XMLSchema" xmlns:xs="http://www.w3.org/2001/XMLSchema" xmlns:p="http://schemas.microsoft.com/office/2006/metadata/properties" xmlns:ns3="16def918-8aa6-4d32-a507-8df69469fc9f" targetNamespace="http://schemas.microsoft.com/office/2006/metadata/properties" ma:root="true" ma:fieldsID="c0dcced12536570fcf1c8b537cc77aa8" ns3:_="">
    <xsd:import namespace="16def918-8aa6-4d32-a507-8df69469fc9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6def918-8aa6-4d32-a507-8df69469fc9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F16B353-2DC5-4BB0-A6B3-D39996901A5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A3058CB-D426-4C55-884F-5BC024168D36}">
  <ds:schemaRefs>
    <ds:schemaRef ds:uri="http://purl.org/dc/dcmitype/"/>
    <ds:schemaRef ds:uri="http://schemas.microsoft.com/office/infopath/2007/PartnerControls"/>
    <ds:schemaRef ds:uri="http://schemas.microsoft.com/office/2006/documentManagement/types"/>
    <ds:schemaRef ds:uri="16def918-8aa6-4d32-a507-8df69469fc9f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4C7A3457-0DE0-4961-9965-5A36BBE12E4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6def918-8aa6-4d32-a507-8df69469fc9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253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n, Sarah (Assoc)</dc:creator>
  <cp:lastModifiedBy>Riman, Sarah (Assoc)</cp:lastModifiedBy>
  <cp:revision>62</cp:revision>
  <dcterms:created xsi:type="dcterms:W3CDTF">2020-09-07T01:57:31Z</dcterms:created>
  <dcterms:modified xsi:type="dcterms:W3CDTF">2021-08-19T05:10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B73957F21AE394984F7C14244486252</vt:lpwstr>
  </property>
</Properties>
</file>